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9EF134-9207-4360-A6FC-51CA14A6AC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896FB-AC90-4554-8533-D5A797871B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ACD5F-BD1C-4FBC-B8C0-803E8144A1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1CF85-B41B-4CBC-913B-179089EE45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9892E-B230-47E1-BDE3-1BC4B553C3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38660-1F70-49F6-9330-8B22DB9756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16C78-29A4-4114-93C3-12E5785205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8476A-C7D3-4D67-88A7-48EB4F8CBC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7B784-9BC7-4E0A-9773-E281132B7C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23157-48F8-4B4B-BCF8-D1258B89A6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CD6C6-F92E-4D93-AC73-6FFB730B4F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5E8AF-3B64-4CFE-9EF1-A2A93BEB81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C2651F-2603-4790-A48D-CADAF90CC466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2"/>
          <p:cNvSpPr/>
          <p:nvPr/>
        </p:nvSpPr>
        <p:spPr>
          <a:xfrm>
            <a:off x="53640" y="8772480"/>
            <a:ext cx="3054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ry Table 1 Lee JJ</a:t>
            </a:r>
            <a:r>
              <a:rPr b="1" lang="ko-KR" sz="1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i="1" lang="en-US" sz="1600" spc="-1" strike="noStrike">
                <a:solidFill>
                  <a:srgbClr val="000000"/>
                </a:solidFill>
                <a:latin typeface="Calibri"/>
              </a:rPr>
              <a:t>et a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09600" y="2268360"/>
          <a:ext cx="6143760" cy="1771920"/>
        </p:xfrm>
        <a:graphic>
          <a:graphicData uri="http://schemas.openxmlformats.org/drawingml/2006/table">
            <a:tbl>
              <a:tblPr/>
              <a:tblGrid>
                <a:gridCol w="2500200"/>
                <a:gridCol w="631800"/>
                <a:gridCol w="536760"/>
                <a:gridCol w="487440"/>
                <a:gridCol w="563400"/>
                <a:gridCol w="611280"/>
                <a:gridCol w="812880"/>
              </a:tblGrid>
              <a:tr h="277920">
                <a:tc gridSpan="7">
                  <a:txBody>
                    <a:bodyPr lIns="5400" rIns="5400" tIns="54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        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pplementary Table 1.  hFAF1 UBA substrate identified by LC/nano ESI-q-TOF tandem MS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708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dentified protein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cession no.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ueries </a:t>
                      </a:r>
                      <a:br>
                        <a:rPr sz="1000"/>
                      </a:b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ched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scot </a:t>
                      </a:r>
                      <a:br>
                        <a:rPr sz="1000"/>
                      </a:b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ore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and no.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.w (Da)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M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at shock 70 kDa protein 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8107   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6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,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70009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208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at shock cognate 71 kDa protein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1142 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7085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1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z family zinc finger protein 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PJY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7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,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5200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140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tyrosine phosphatase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-receptor type 14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15678 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35175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K954-GlyGly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직사각형 25"/>
          <p:cNvSpPr/>
          <p:nvPr/>
        </p:nvSpPr>
        <p:spPr>
          <a:xfrm>
            <a:off x="765000" y="1703520"/>
            <a:ext cx="5185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List of UBA substrates in hFAF1 identified by UPLC/nano ESI-q-TOF tandem MS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0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9-17T05:37:55Z</dcterms:created>
  <dc:creator>표홍렬 (김영미)</dc:creator>
  <dc:description/>
  <dc:language>en-US</dc:language>
  <cp:lastModifiedBy>jjkim</cp:lastModifiedBy>
  <dcterms:modified xsi:type="dcterms:W3CDTF">2012-05-31T21:32:30Z</dcterms:modified>
  <cp:revision>529</cp:revision>
  <dc:subject/>
  <dc:title>PowerPoint 프레젠테이션</dc:title>
</cp:coreProperties>
</file>